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taki, Anastasia" initials="FA" lastIdx="6" clrIdx="0">
    <p:extLst>
      <p:ext uri="{19B8F6BF-5375-455C-9EA6-DF929625EA0E}">
        <p15:presenceInfo xmlns:p15="http://schemas.microsoft.com/office/powerpoint/2012/main" userId="S::k2031904@kcl.ac.uk::7d68da83-c501-4245-86c4-1ae047af3293" providerId="AD"/>
      </p:ext>
    </p:extLst>
  </p:cmAuthor>
  <p:cmAuthor id="2" name="Claudia Prieto" initials="CP" lastIdx="1" clrIdx="1">
    <p:extLst>
      <p:ext uri="{19B8F6BF-5375-455C-9EA6-DF929625EA0E}">
        <p15:presenceInfo xmlns:p15="http://schemas.microsoft.com/office/powerpoint/2012/main" userId="bdf550086614199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8088"/>
    <a:srgbClr val="F5B0E8"/>
    <a:srgbClr val="46D3C6"/>
    <a:srgbClr val="7ED3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446"/>
    <p:restoredTop sz="78493"/>
  </p:normalViewPr>
  <p:slideViewPr>
    <p:cSldViewPr snapToGrid="0" snapToObjects="1">
      <p:cViewPr>
        <p:scale>
          <a:sx n="146" d="100"/>
          <a:sy n="146" d="100"/>
        </p:scale>
        <p:origin x="-3096" y="-264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8C7467-FB31-DF4A-8414-C9C0C7C34915}" type="datetimeFigureOut">
              <a:rPr lang="en-US" smtClean="0"/>
              <a:t>1/1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A4AD84-62B4-C04C-8069-21DAD12E8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052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M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A4AD84-62B4-C04C-8069-21DAD12E81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974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6A01C-C558-A94C-9F7A-09A8A11A65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ADF8B5-D8A2-A94A-A2D4-7AA3ECB253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F41C7-2F3A-CB45-8C31-0BEE8FD96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7C55C7-DF34-BA41-8A41-A5E0EAE0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0C0BC3-80F9-A148-B784-2B62FC23F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680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DB5CC-D1FE-6048-BE6D-AF0336815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0BA95F-F6A2-D64F-B39F-72FD6F684C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924D13-47C8-5B4E-873D-3490954FF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321F34-FC9A-5047-B777-99B6D95EA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DDC34C-CA31-CB47-A8D1-F7F7CC864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338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972434-D10C-3F45-BCDE-27752E20AE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C4A4D6-A832-9C4B-8B8A-16EEA954B1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A7EB6F-998A-984E-B02A-16FFC47C7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442C7D-6E57-EE41-ADEF-D139AF064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7ECB43-5657-FE49-99F7-8E4E2C84F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834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0A16B-1761-4343-BEC8-A0418F867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3EE7C9-590A-6840-90BE-A0E5415BAB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0C8C30-D52D-E24A-BDD8-F2BD026ED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A1B46D-C1D6-F84E-ADFB-6359006B3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42A28-0462-8246-8D87-328DFFE03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296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0FFAD5-2B96-B64B-AE4E-B85473487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385753-752F-7A4A-AE99-5C2CAECEFE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1BA65C-489C-534D-9217-F2B77DBA5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3CDD1-F862-174D-BD7D-5B908D70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D1F8FE-BB66-9347-A205-0E8FEC607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767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F6E04-5117-5A4D-B8A9-EE2E2D026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6F0CF2-9821-E842-98EC-387EAF0E12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770317-71BB-A34B-B288-305D01E6E5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31DDFA-FC49-EB49-89CD-9A41EFD02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17BF81-B693-3D47-9844-5280AA981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E73E94-87E3-1647-9471-CEFB042A5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232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F145B-3E34-B440-97DC-83FE89F9B6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10ECA9-C458-104F-A720-1C4F9A8BD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97ED80-8E77-B74F-B908-93F5D357B5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A47782-70D7-5C43-AF5B-E8E1557C25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4A2D4F-AC18-CF46-B999-5770615625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17539F-B6E0-EC49-94A4-2C8FA738E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D36BF6-F39B-E746-99C9-5CBCB7F2F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080505-692D-414E-978E-EC0AD95E2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481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BBF39-06A1-C642-8754-A12761414A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706C42-1676-B142-9E15-441A2593F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E6685A-A5F0-F244-A95A-33B29BE0D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0DAEE48-4978-1442-B8D2-ECE2C0F76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8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D187E3-9B65-1349-BE41-D031C1CEC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E2FEFD-145B-3F45-AC1D-E6312485E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9FFB3F-438C-2A44-9CD8-9CB0ED24C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912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D3F55D-5DE3-554E-9C82-F1EDC723C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53FCEA-5625-AE48-BB15-4853EE3E13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18B7B8-1E16-E549-97AB-60B1075ED3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A62DFC-06FE-014B-AA8D-1B573EDB9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6F0DA-5168-8545-B43F-B31C1FD8C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887BC4-A818-2746-A6BA-476C41C9B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124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35029-344C-0F44-9A29-F046C7495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635A3C-9E91-8743-A430-17803F542D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5A2F17-AE91-DE49-9FDD-779A5FC94F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B275EE-3525-A14D-BE0A-D60D4D796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858B2A-C680-4449-85EB-7F7584909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60FFAE-133D-A541-814A-C9FEEECB9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473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C7A841-3E9E-5043-A02E-23EFCE72B1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F2F148-28E8-9346-A5D4-6D01DE450A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7356C9-C222-E442-B1D1-A7879A7BC2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42F7F-282C-4B41-895A-12D95ADEB8B1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B24267-066B-C64A-971D-B77DFB637E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C1589-5C8B-8744-8656-1DA7EADE4C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397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C2113EF-EF2E-094B-85BA-930DB5EA95EA}"/>
              </a:ext>
            </a:extLst>
          </p:cNvPr>
          <p:cNvSpPr txBox="1"/>
          <p:nvPr/>
        </p:nvSpPr>
        <p:spPr>
          <a:xfrm>
            <a:off x="600351" y="6436645"/>
            <a:ext cx="2156220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articipant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5CECA6-C313-1646-B0C9-66F01705A616}"/>
              </a:ext>
            </a:extLst>
          </p:cNvPr>
          <p:cNvSpPr txBox="1"/>
          <p:nvPr/>
        </p:nvSpPr>
        <p:spPr>
          <a:xfrm rot="16200000">
            <a:off x="-739201" y="1004255"/>
            <a:ext cx="21497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ully Sample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01D535-A638-DC4C-977E-20E1C7AB9B85}"/>
              </a:ext>
            </a:extLst>
          </p:cNvPr>
          <p:cNvSpPr txBox="1"/>
          <p:nvPr/>
        </p:nvSpPr>
        <p:spPr>
          <a:xfrm rot="16200000">
            <a:off x="-734576" y="3089598"/>
            <a:ext cx="2140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jMS-VN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F6DCB78-671D-C348-9834-A02D3C77E3FB}"/>
              </a:ext>
            </a:extLst>
          </p:cNvPr>
          <p:cNvSpPr txBox="1"/>
          <p:nvPr/>
        </p:nvSpPr>
        <p:spPr>
          <a:xfrm rot="16200000">
            <a:off x="-727037" y="5122421"/>
            <a:ext cx="215622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mpressed Sensin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539105-BFEA-1D48-9CF7-565FF3F1C966}"/>
              </a:ext>
            </a:extLst>
          </p:cNvPr>
          <p:cNvSpPr txBox="1"/>
          <p:nvPr/>
        </p:nvSpPr>
        <p:spPr>
          <a:xfrm>
            <a:off x="2738956" y="6460280"/>
            <a:ext cx="2156220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articipant 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2504A61-4478-8049-974A-57126A3757A6}"/>
              </a:ext>
            </a:extLst>
          </p:cNvPr>
          <p:cNvSpPr txBox="1"/>
          <p:nvPr/>
        </p:nvSpPr>
        <p:spPr>
          <a:xfrm>
            <a:off x="5071120" y="6436645"/>
            <a:ext cx="2156220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articipant 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8BD71AE-B91D-7B47-8B8A-00E304F66FFB}"/>
              </a:ext>
            </a:extLst>
          </p:cNvPr>
          <p:cNvSpPr txBox="1"/>
          <p:nvPr/>
        </p:nvSpPr>
        <p:spPr>
          <a:xfrm>
            <a:off x="7257867" y="6460280"/>
            <a:ext cx="2156220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articipant 1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918B90C-9143-234B-B179-392003D5828B}"/>
              </a:ext>
            </a:extLst>
          </p:cNvPr>
          <p:cNvSpPr txBox="1"/>
          <p:nvPr/>
        </p:nvSpPr>
        <p:spPr>
          <a:xfrm>
            <a:off x="9534152" y="6453920"/>
            <a:ext cx="2156220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Participant 1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09330A35-C891-B04D-B931-FF6E39E0B2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786" t="12661" r="22786" b="13535"/>
          <a:stretch/>
        </p:blipFill>
        <p:spPr>
          <a:xfrm>
            <a:off x="582735" y="84568"/>
            <a:ext cx="2156221" cy="215622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6FE3E59D-DE02-3440-AD82-657B461EA2F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597" t="11880" r="22597" b="16505"/>
          <a:stretch/>
        </p:blipFill>
        <p:spPr>
          <a:xfrm>
            <a:off x="9534152" y="84568"/>
            <a:ext cx="2174370" cy="215622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23B96EE7-31A6-B64E-94E9-1EBFF47674D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786" t="13384" r="22786" b="13225"/>
          <a:stretch/>
        </p:blipFill>
        <p:spPr>
          <a:xfrm>
            <a:off x="2819441" y="84568"/>
            <a:ext cx="2156219" cy="215622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5813760A-E871-9C42-8905-FBDAF7F41D9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7503" t="9519" r="17905" b="14316"/>
          <a:stretch/>
        </p:blipFill>
        <p:spPr>
          <a:xfrm>
            <a:off x="5056145" y="84568"/>
            <a:ext cx="2162690" cy="215622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BE26926-5BD4-D849-B0E5-11D5B215048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705" t="12751" r="22703" b="10682"/>
          <a:stretch/>
        </p:blipFill>
        <p:spPr>
          <a:xfrm>
            <a:off x="7299320" y="84568"/>
            <a:ext cx="2154346" cy="215622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8A992476-9C77-D84C-BBBE-510B489B8E2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2714" t="12660" r="22788" b="13538"/>
          <a:stretch/>
        </p:blipFill>
        <p:spPr>
          <a:xfrm>
            <a:off x="573308" y="2188614"/>
            <a:ext cx="2159028" cy="215622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64112429-519F-7A45-A986-9ABA8B41D9E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2786" t="13059" r="22786" b="12897"/>
          <a:stretch/>
        </p:blipFill>
        <p:spPr>
          <a:xfrm>
            <a:off x="2813482" y="2188614"/>
            <a:ext cx="2156220" cy="215622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3C30F8C-973A-944D-8F3A-50FFBD89487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6516" t="9518" r="18892" b="14317"/>
          <a:stretch/>
        </p:blipFill>
        <p:spPr>
          <a:xfrm>
            <a:off x="5050848" y="2188614"/>
            <a:ext cx="2162691" cy="215622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28D0094D-C5DB-564C-8934-DAA0314B834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2603" t="12752" r="22704" b="10682"/>
          <a:stretch/>
        </p:blipFill>
        <p:spPr>
          <a:xfrm>
            <a:off x="7294685" y="2188614"/>
            <a:ext cx="2158323" cy="215622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0D3175BD-048D-0747-9BF9-981B117FEFC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22286" t="11785" r="22260" b="16423"/>
          <a:stretch/>
        </p:blipFill>
        <p:spPr>
          <a:xfrm>
            <a:off x="9534152" y="2188614"/>
            <a:ext cx="2174370" cy="215622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1903E687-CE4C-D041-B7AD-950FF661A4A5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2644" t="12735" r="22856" b="13524"/>
          <a:stretch/>
        </p:blipFill>
        <p:spPr>
          <a:xfrm>
            <a:off x="582735" y="4330766"/>
            <a:ext cx="2159029" cy="215622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45D1692E-9DDC-A743-BE15-551CDDE2B48B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22786" t="12974" r="22786" b="13460"/>
          <a:stretch/>
        </p:blipFill>
        <p:spPr>
          <a:xfrm>
            <a:off x="2818230" y="4330766"/>
            <a:ext cx="2156220" cy="215622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9968642E-7F5B-C14D-B8AC-291576CAF7AA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25528" t="9568" r="19880" b="14267"/>
          <a:stretch/>
        </p:blipFill>
        <p:spPr>
          <a:xfrm>
            <a:off x="5050916" y="4330766"/>
            <a:ext cx="2162691" cy="215622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1940C5F8-2431-514B-B1CD-449708747AD5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22502" t="12509" r="22805" b="10425"/>
          <a:stretch/>
        </p:blipFill>
        <p:spPr>
          <a:xfrm>
            <a:off x="7290073" y="4330766"/>
            <a:ext cx="2158324" cy="215622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82741CD6-1B01-D040-8C28-F65A78B92B26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22353" t="11880" r="22194" b="16505"/>
          <a:stretch/>
        </p:blipFill>
        <p:spPr>
          <a:xfrm>
            <a:off x="9524864" y="4330766"/>
            <a:ext cx="2174370" cy="215622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3CAA0C5D-B498-AD43-A9D8-425C810F537F}"/>
              </a:ext>
            </a:extLst>
          </p:cNvPr>
          <p:cNvSpPr txBox="1"/>
          <p:nvPr/>
        </p:nvSpPr>
        <p:spPr>
          <a:xfrm>
            <a:off x="1929471" y="989061"/>
            <a:ext cx="582275" cy="911339"/>
          </a:xfrm>
          <a:prstGeom prst="rect">
            <a:avLst/>
          </a:prstGeom>
          <a:noFill/>
          <a:ln w="9525">
            <a:solidFill>
              <a:schemeClr val="accent4">
                <a:lumMod val="20000"/>
                <a:lumOff val="80000"/>
              </a:schemeClr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19A97FD-E5ED-674B-B9B1-53325389462C}"/>
              </a:ext>
            </a:extLst>
          </p:cNvPr>
          <p:cNvSpPr txBox="1"/>
          <p:nvPr/>
        </p:nvSpPr>
        <p:spPr>
          <a:xfrm>
            <a:off x="1929471" y="3087585"/>
            <a:ext cx="582275" cy="894693"/>
          </a:xfrm>
          <a:prstGeom prst="rect">
            <a:avLst/>
          </a:prstGeom>
          <a:noFill/>
          <a:ln w="9525">
            <a:solidFill>
              <a:schemeClr val="accent4">
                <a:lumMod val="20000"/>
                <a:lumOff val="80000"/>
              </a:schemeClr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D58618F-0041-B744-B4A0-60A3B5B9A51D}"/>
              </a:ext>
            </a:extLst>
          </p:cNvPr>
          <p:cNvSpPr txBox="1"/>
          <p:nvPr/>
        </p:nvSpPr>
        <p:spPr>
          <a:xfrm>
            <a:off x="1929471" y="5203664"/>
            <a:ext cx="582275" cy="868592"/>
          </a:xfrm>
          <a:prstGeom prst="rect">
            <a:avLst/>
          </a:prstGeom>
          <a:noFill/>
          <a:ln w="9525">
            <a:solidFill>
              <a:schemeClr val="accent4">
                <a:lumMod val="20000"/>
                <a:lumOff val="80000"/>
              </a:schemeClr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DC6DA27-0C2C-9D4A-B295-F3347E771AD9}"/>
              </a:ext>
            </a:extLst>
          </p:cNvPr>
          <p:cNvSpPr txBox="1"/>
          <p:nvPr/>
        </p:nvSpPr>
        <p:spPr>
          <a:xfrm>
            <a:off x="3769856" y="3517099"/>
            <a:ext cx="850899" cy="338554"/>
          </a:xfrm>
          <a:prstGeom prst="rect">
            <a:avLst/>
          </a:prstGeom>
          <a:noFill/>
          <a:ln w="9525">
            <a:solidFill>
              <a:srgbClr val="00B0F0"/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D8391B2-6828-5341-B96E-D48CA3FC61EF}"/>
              </a:ext>
            </a:extLst>
          </p:cNvPr>
          <p:cNvSpPr txBox="1"/>
          <p:nvPr/>
        </p:nvSpPr>
        <p:spPr>
          <a:xfrm>
            <a:off x="3817066" y="1447008"/>
            <a:ext cx="850899" cy="338554"/>
          </a:xfrm>
          <a:prstGeom prst="rect">
            <a:avLst/>
          </a:prstGeom>
          <a:noFill/>
          <a:ln w="9525">
            <a:solidFill>
              <a:srgbClr val="00B0F0"/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9B5B408-34A7-FA4D-88E6-5C8523BDB97E}"/>
              </a:ext>
            </a:extLst>
          </p:cNvPr>
          <p:cNvSpPr txBox="1"/>
          <p:nvPr/>
        </p:nvSpPr>
        <p:spPr>
          <a:xfrm>
            <a:off x="3781655" y="5776354"/>
            <a:ext cx="850899" cy="338554"/>
          </a:xfrm>
          <a:prstGeom prst="rect">
            <a:avLst/>
          </a:prstGeom>
          <a:noFill/>
          <a:ln w="9525">
            <a:solidFill>
              <a:srgbClr val="00B0F0"/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84412F4-4CC8-4446-914C-213A22957F8F}"/>
              </a:ext>
            </a:extLst>
          </p:cNvPr>
          <p:cNvSpPr txBox="1"/>
          <p:nvPr/>
        </p:nvSpPr>
        <p:spPr>
          <a:xfrm>
            <a:off x="10960100" y="1066800"/>
            <a:ext cx="558800" cy="800100"/>
          </a:xfrm>
          <a:prstGeom prst="rect">
            <a:avLst/>
          </a:prstGeom>
          <a:noFill/>
          <a:ln w="9525">
            <a:solidFill>
              <a:srgbClr val="FF0000"/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B10F1EB-20E2-ED49-A32F-0548B39F4C3C}"/>
              </a:ext>
            </a:extLst>
          </p:cNvPr>
          <p:cNvSpPr txBox="1"/>
          <p:nvPr/>
        </p:nvSpPr>
        <p:spPr>
          <a:xfrm>
            <a:off x="10960100" y="3182178"/>
            <a:ext cx="558800" cy="800100"/>
          </a:xfrm>
          <a:prstGeom prst="rect">
            <a:avLst/>
          </a:prstGeom>
          <a:noFill/>
          <a:ln w="9525">
            <a:solidFill>
              <a:srgbClr val="FF0000"/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F6D3103-AE1F-F94B-B705-9123A29C413A}"/>
              </a:ext>
            </a:extLst>
          </p:cNvPr>
          <p:cNvSpPr txBox="1"/>
          <p:nvPr/>
        </p:nvSpPr>
        <p:spPr>
          <a:xfrm>
            <a:off x="10960100" y="5324330"/>
            <a:ext cx="558800" cy="800100"/>
          </a:xfrm>
          <a:prstGeom prst="rect">
            <a:avLst/>
          </a:prstGeom>
          <a:noFill/>
          <a:ln w="9525">
            <a:solidFill>
              <a:srgbClr val="FF0000"/>
            </a:solidFill>
            <a:prstDash val="sysDot"/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8201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62</TotalTime>
  <Words>19</Words>
  <Application>Microsoft Macintosh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taki, Anastasia</dc:creator>
  <cp:lastModifiedBy>Fotaki, Anastasia</cp:lastModifiedBy>
  <cp:revision>112</cp:revision>
  <dcterms:created xsi:type="dcterms:W3CDTF">2020-10-28T20:14:06Z</dcterms:created>
  <dcterms:modified xsi:type="dcterms:W3CDTF">2022-01-18T22:53:21Z</dcterms:modified>
</cp:coreProperties>
</file>